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670675" cy="9820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A4C96-973E-4B68-9F66-EE33DD55C4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A366B-CE40-4778-934E-876B589EDA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4130D-75EF-4387-907B-9920D3C4A0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C656E-8E2F-47DD-BC8E-6A40E6DF63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312FF-D8C4-403E-9574-40A57F0B21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317C5-DE01-4E87-AC01-D9274CFBBC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02EFBB-BCF9-42D2-8E86-9F1A12A985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631F5-0BFB-4EAF-B828-D099624EAA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85C6C-F3B3-46A7-A10A-52C85935D0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12F68-4165-483D-BF10-3AE6A032EF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BBF16-448A-435E-B479-CEF9C0567C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79404-EA3D-4584-91D8-DC3178986E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A8AC30-A472-4050-AD39-FE9EEC88E01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58800" y="169236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i="1" lang="en-GB" sz="1400" spc="-1" strike="noStrike" u="sng">
                <a:solidFill>
                  <a:srgbClr val="ff6600"/>
                </a:solidFill>
                <a:uFillTx/>
                <a:latin typeface="Courier New"/>
              </a:rPr>
              <a:t>A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T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tggtgagcaagggcgaggagctgttcaccggggtggtgcccatc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gtcgagctggacggcgacgtaaacggccacaagttcagcgtgtccggcgagggcgagggcgatgccacctacggcaagctgaccctgaagttcatctgca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AC</a:t>
            </a:r>
            <a:r>
              <a:rPr b="1" lang="en-GB" sz="14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58800" y="310032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AC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atcctggtccacacttttacgataaaaacacaagatttt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actatgaactgatcaataatcattcctaaaagaccacacttttgttttgtttctaaagtaatttttactgttataaca</a:t>
            </a:r>
            <a:r>
              <a:rPr b="1" i="1" lang="en-GB" sz="1400" spc="-1" strike="noStrike" u="sng">
                <a:solidFill>
                  <a:srgbClr val="ff6600"/>
                </a:solidFill>
                <a:uFillTx/>
                <a:latin typeface="Courier New"/>
              </a:rPr>
              <a:t>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T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58800" y="456552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i="1" lang="en-GB" sz="1400" spc="-1" strike="noStrike" u="sng">
                <a:solidFill>
                  <a:srgbClr val="ff6600"/>
                </a:solidFill>
                <a:uFillTx/>
                <a:latin typeface="Courier New"/>
              </a:rPr>
              <a:t>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T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ctgcccgtgccctggcccaccctcgtgaccaccttcagctacgg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gcagtgcttcagccgctaccccgaccacatgaagcagcacgacttcttcaagtccgccat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G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58800" y="601812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G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ttttctttctctactcaattttctccaagatccaatatt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aagactgatctatagttaaaattaatctctactccattcttgttacctc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ACG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58800" y="741996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AC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tccaggagcgcaccatcttcttcaaggacgacggcaactacaag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ccgcgccgaggtgaagttcgagggcgacaccctggtgaaccgcatcga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GA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62120" y="306360"/>
            <a:ext cx="5611680" cy="112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Sequence of GFP exon and intron modul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u="sng">
                <a:solidFill>
                  <a:srgbClr val="000000"/>
                </a:solidFill>
                <a:uFillTx/>
                <a:latin typeface="Arial"/>
              </a:rPr>
              <a:t>(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Exons are shown in bold black, and intron in bold red italics letters.  The sequences of the flanking sequences used for assembly are shown in capital underlined letters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75360" y="147492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1 (exon 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76080" y="2940120"/>
            <a:ext cx="191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2 (intron 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75360" y="433404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3 (exon 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76080" y="5819760"/>
            <a:ext cx="191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4 (intron 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75360" y="725976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5 (exon 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"/>
          <p:cNvSpPr/>
          <p:nvPr/>
        </p:nvSpPr>
        <p:spPr>
          <a:xfrm>
            <a:off x="600120" y="267336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cttcaaggaggacggcaacatcctggggcacaagctggagtac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ctacaacagccacaacgtctatatcatggccgacaagcagaagaacg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00120" y="406224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ctgtctttcctatttcatatgtttaatcctaggaatttgat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attgattgtatgtatgtcgatcccaagactttcttgttcacttatatcttaactctctctttgctgtttcttgc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AAC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00120" y="5583240"/>
            <a:ext cx="583884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AAC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ttcaagatccgccacaacatcgaggacggcagcgtgcagctcgccg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ccactaccagcagaacacccccatcggcgacggccccgtgctgctgcccgacaaccactacctgagcacccagtccgccctgagcaaagaccccaacgagaagcgcgatcacatggtcctgctggagttcgtgaccgccgccgggatcactcacggcatggacgagctgtacaa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CTT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64200" y="254016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7 (exon 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64920" y="3890880"/>
            <a:ext cx="191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8 (intron 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64200" y="542448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9 (exon 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61960" y="1228680"/>
            <a:ext cx="583884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ggtctc a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GA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agcaactgtgttttaatcaatttcttgtcaggatatat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attataacttaatttttgagaaatctgtagtatttggcgtgaaatgagtttgctttttggtttctcccgtgttat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G</a:t>
            </a:r>
            <a:r>
              <a:rPr b="1" i="1" lang="en-GB" sz="1400" spc="-1" strike="noStrike">
                <a:solidFill>
                  <a:srgbClr val="ff6600"/>
                </a:solidFill>
                <a:latin typeface="Courier New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</a:rPr>
              <a:t>t g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26760" y="1041480"/>
            <a:ext cx="191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ourier New"/>
              </a:rPr>
              <a:t>module 6 (intron 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"/>
          <p:cNvSpPr/>
          <p:nvPr/>
        </p:nvSpPr>
        <p:spPr>
          <a:xfrm>
            <a:off x="808200" y="1408320"/>
            <a:ext cx="5402160" cy="67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ff6600"/>
                </a:solidFill>
                <a:uFillTx/>
                <a:latin typeface="Courier New"/>
              </a:rPr>
              <a:t>A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T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tggtgagcaagggcgaggagctgttcaccggggtggtgcccatcctggtcgagctggacggcgacgtaaacggccacaagttcagcgtgtccggcgagggcgagggcgatgccacctacggcaagctgaccctgaagttcatctgca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AC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atcctggtccacacttttacgataaaaacacaagattttaaactatgaactgatcaataatcattcctaaaagaccacacttttgttttgtttctaaagtaatttttactgttataaca</a:t>
            </a:r>
            <a:r>
              <a:rPr b="1" i="1" lang="en-GB" sz="1400" spc="-1" strike="noStrike" u="sng">
                <a:solidFill>
                  <a:srgbClr val="ff6600"/>
                </a:solidFill>
                <a:uFillTx/>
                <a:latin typeface="Courier New"/>
              </a:rPr>
              <a:t>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T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ctgcccgtgccctggcccaccctcgtgaccaccttcagctacggcgtgcagtgcttcagccgctaccccgaccacatgaagcagcacgacttcttcaagtccgccat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CCG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ttttctttctctactcaattttctccaagatccaatatttgaagactgatctatagttaaaattaatctctactccattcttgttacctc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AC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tccaggagcgcaccatcttcttcaaggacgacggcaactacaagacccgcgccgaggtgaagttcgagggcgacaccctggtgaaccgcatcga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TGA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aaagcaactgtgttttaatcaatttcttgtcaggatatatggattataacttaatttttgagaaatctgtagtatttggcgtgaaatgagtttgctttttggtttctcccgtgttat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cttcaaggaggacggcaacatcctggggcacaagctggagtacaactacaacagccacaacgtctatatcatggccgacaagcagaagaacggc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ATCA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i="1" lang="en-GB" sz="1200" spc="-1" strike="noStrike">
                <a:solidFill>
                  <a:srgbClr val="ff6600"/>
                </a:solidFill>
                <a:latin typeface="Courier New"/>
              </a:rPr>
              <a:t>gtctgtctttcctatttcatatgtttaatcctaggaatttgatcaattgattgtatgtatgtcgatcccaagactttcttgttcacttatatcttaactctctctttgctgtttcttgcag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AAC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</a:rPr>
              <a:t>ttcaagatccgccacaacatcgaggacggcagcgtgcagctcgccgaccactaccagcagaacacccccatcggcgacggccccgtgctgctgcccgacaaccactacctgagcacccagtccgccctgagcaaagaccccaacgagaagcgcgatcacatggtcctgctggagttcgtgaccgccgccgggatcactcacggcatggacgagctgtacaag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Courier New"/>
              </a:rPr>
              <a:t>GC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143000" y="450720"/>
            <a:ext cx="4848120" cy="91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Arial"/>
              </a:rPr>
              <a:t>Sequence of the GFP construct with introns, pGFP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u="sng">
                <a:solidFill>
                  <a:srgbClr val="000000"/>
                </a:solidFill>
                <a:uFillTx/>
                <a:latin typeface="Arial"/>
              </a:rPr>
              <a:t>(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Exons are shown in black, and intron in red italics letters.  The sequences of the flanking sequences used for assembly are shown in capital underlined letters.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19T18:12:33Z</dcterms:created>
  <dc:creator>icsym</dc:creator>
  <dc:description/>
  <dc:language>en-US</dc:language>
  <cp:lastModifiedBy>icsym</cp:lastModifiedBy>
  <dcterms:modified xsi:type="dcterms:W3CDTF">2009-04-22T21:12:02Z</dcterms:modified>
  <cp:revision>69</cp:revision>
  <dc:subject/>
  <dc:title>Slide 1</dc:title>
</cp:coreProperties>
</file>